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F7B91E-6F49-4B93-86C2-4FAEEC57AE7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448540-0002-4FB1-B513-923981D849D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D46213-B4FB-484E-A192-0E2E2687A4A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519CCB-A397-4AA3-BB0D-D59A91E19D4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F8D1FD-C294-409E-90AC-9B08542FCA4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AB7925-21C2-4942-A482-ADC464B39E3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40B1E5-E59F-4499-8EA4-FEF7D928C15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18E353-DE8A-4277-87A8-0B1B340EC46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BAE024-888A-4BF6-A9F9-F16DA4CAE96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02952F-2318-464B-A901-B0415570361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343524-719A-4937-B5A7-DF9F343C2CE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DB26BA-E156-4768-A38F-B5454ACF65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4D9F592-06FB-4E8D-A42E-95E4B72A156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5445000" y="2467080"/>
            <a:ext cx="28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5445000" y="2720880"/>
            <a:ext cx="28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5445000" y="2936880"/>
            <a:ext cx="28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5451480" y="3243240"/>
            <a:ext cx="28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5457960" y="3747960"/>
            <a:ext cx="288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907920" y="4952880"/>
            <a:ext cx="5473800" cy="3379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2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Figure S1.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i="1" lang="en-GB" sz="1200" spc="-1" strike="noStrike">
                <a:solidFill>
                  <a:srgbClr val="000000"/>
                </a:solidFill>
                <a:latin typeface="Arial"/>
              </a:rPr>
              <a:t>vanB2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 subtype determination. Long PCR products with DNA from outbreak and non-outbreak strains were subsequently digested with</a:t>
            </a:r>
            <a:r>
              <a:rPr b="1" i="1" lang="en-GB" sz="1200" spc="-1" strike="noStrike">
                <a:solidFill>
                  <a:srgbClr val="000000"/>
                </a:solidFill>
                <a:latin typeface="Arial"/>
              </a:rPr>
              <a:t> BspH1/DraI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.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Underlined lane numbers designate “non-outbreak strains”. Legend: O, ST192 outbreak strain; NO, non-outbreak strains. M, Gene Ruler 100bp Plus (Thermo Fisher Scientific); 1, UW7606(O); 2, UW7609(O); 3, UW7612(O); 4, UW7813(O); 5, UW7819(O); 6, UW7842(O); 7, UW7610 (NO, ST117); 8, UW7611 (O, ST192); 9, UW7835 (O); 10, UW7842 (O); 11, UW7845(O); 12, UW7852 (NO, ST203) [UW7859 (NO, ST203) did not reveal a long PCR product; not shown]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858600" y="1843200"/>
            <a:ext cx="46612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M     1      2     3     4     5      6     </a:t>
            </a:r>
            <a:r>
              <a:rPr b="0" lang="en-US" sz="1300" spc="-1" strike="noStrike" u="sng">
                <a:solidFill>
                  <a:srgbClr val="000000"/>
                </a:solidFill>
                <a:uFillTx/>
                <a:latin typeface="Arial"/>
              </a:rPr>
              <a:t>7</a:t>
            </a: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     8      9    10   11   </a:t>
            </a:r>
            <a:r>
              <a:rPr b="0" lang="en-US" sz="1300" spc="-1" strike="noStrike" u="sng">
                <a:solidFill>
                  <a:srgbClr val="000000"/>
                </a:solidFill>
                <a:uFillTx/>
                <a:latin typeface="Arial"/>
              </a:rPr>
              <a:t>12</a:t>
            </a: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    M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" name="" descr=""/>
          <p:cNvPicPr/>
          <p:nvPr/>
        </p:nvPicPr>
        <p:blipFill>
          <a:blip r:embed="rId1"/>
          <a:srcRect l="0" t="38291" r="8824" b="8955"/>
          <a:stretch/>
        </p:blipFill>
        <p:spPr>
          <a:xfrm>
            <a:off x="765000" y="2205000"/>
            <a:ext cx="4835880" cy="1944720"/>
          </a:xfrm>
          <a:prstGeom prst="rect">
            <a:avLst/>
          </a:prstGeom>
          <a:ln w="0">
            <a:noFill/>
          </a:ln>
        </p:spPr>
      </p:pic>
      <p:sp>
        <p:nvSpPr>
          <p:cNvPr id="49" name=""/>
          <p:cNvSpPr/>
          <p:nvPr/>
        </p:nvSpPr>
        <p:spPr>
          <a:xfrm>
            <a:off x="5736240" y="1639800"/>
            <a:ext cx="54648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300" spc="-1" strike="noStrike">
                <a:solidFill>
                  <a:srgbClr val="000000"/>
                </a:solidFill>
                <a:latin typeface="Arial"/>
              </a:rPr>
              <a:t>Size </a:t>
            </a:r>
            <a:br>
              <a:rPr sz="1300"/>
            </a:br>
            <a:r>
              <a:rPr b="0" lang="de-DE" sz="1300" spc="-1" strike="noStrike">
                <a:solidFill>
                  <a:srgbClr val="000000"/>
                </a:solidFill>
                <a:latin typeface="Arial"/>
              </a:rPr>
              <a:t>in bp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5736960" y="2289240"/>
            <a:ext cx="5464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300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5736960" y="2576520"/>
            <a:ext cx="5464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200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5736960" y="2792520"/>
            <a:ext cx="5464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150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5736960" y="3081240"/>
            <a:ext cx="5464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100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5828760" y="3584520"/>
            <a:ext cx="4550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50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1-05T10:01:14Z</dcterms:created>
  <dc:creator>wernerg</dc:creator>
  <dc:description/>
  <dc:language>en-US</dc:language>
  <cp:lastModifiedBy>wernerg</cp:lastModifiedBy>
  <dcterms:modified xsi:type="dcterms:W3CDTF">2012-04-12T12:16:29Z</dcterms:modified>
  <cp:revision>14</cp:revision>
  <dc:subject/>
  <dc:title>Folie 1</dc:title>
</cp:coreProperties>
</file>